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177" autoAdjust="0"/>
  </p:normalViewPr>
  <p:slideViewPr>
    <p:cSldViewPr snapToGrid="0">
      <p:cViewPr varScale="1">
        <p:scale>
          <a:sx n="73" d="100"/>
          <a:sy n="73" d="100"/>
        </p:scale>
        <p:origin x="58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1EC4-9F1C-4847-8882-F6357EDDB76F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8BD744-C0A7-4669-8130-C33548C2E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178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8BD744-C0A7-4669-8130-C33548C2EEF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33031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841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632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445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640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360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4255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5541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0629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185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763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683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79D03-24D0-473D-AD9A-3AC321723EB5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3F8B8-D8BB-4202-ADF0-6744364DB9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51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65273" y="728131"/>
            <a:ext cx="11649146" cy="5536256"/>
            <a:chOff x="365273" y="728131"/>
            <a:chExt cx="11649146" cy="5536256"/>
          </a:xfrm>
        </p:grpSpPr>
        <p:grpSp>
          <p:nvGrpSpPr>
            <p:cNvPr id="97" name="组合 96"/>
            <p:cNvGrpSpPr/>
            <p:nvPr/>
          </p:nvGrpSpPr>
          <p:grpSpPr>
            <a:xfrm>
              <a:off x="365273" y="728131"/>
              <a:ext cx="11649146" cy="5536256"/>
              <a:chOff x="577922" y="-32065"/>
              <a:chExt cx="11649146" cy="5536256"/>
            </a:xfrm>
          </p:grpSpPr>
          <p:sp>
            <p:nvSpPr>
              <p:cNvPr id="4" name="文本框 3"/>
              <p:cNvSpPr txBox="1"/>
              <p:nvPr/>
            </p:nvSpPr>
            <p:spPr>
              <a:xfrm>
                <a:off x="627019" y="-32065"/>
                <a:ext cx="10724603" cy="6489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ble 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2. 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ivariate analysis and multivariate analysis of the correlation of the expression of NRP1 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ith 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 among GBM patients.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直接连接符 5"/>
              <p:cNvCxnSpPr/>
              <p:nvPr/>
            </p:nvCxnSpPr>
            <p:spPr>
              <a:xfrm>
                <a:off x="731520" y="609776"/>
                <a:ext cx="1085657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文本框 6"/>
              <p:cNvSpPr txBox="1"/>
              <p:nvPr/>
            </p:nvSpPr>
            <p:spPr>
              <a:xfrm>
                <a:off x="983610" y="756096"/>
                <a:ext cx="13062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ameter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5126342" y="540363"/>
                <a:ext cx="22468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ivariate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alysis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8808005" y="587757"/>
                <a:ext cx="212924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ltivariate analysis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" name="直接连接符 9"/>
              <p:cNvCxnSpPr/>
              <p:nvPr/>
            </p:nvCxnSpPr>
            <p:spPr>
              <a:xfrm>
                <a:off x="731520" y="1285060"/>
                <a:ext cx="1085657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577922" y="5089878"/>
                <a:ext cx="1095756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文本框 17"/>
              <p:cNvSpPr txBox="1"/>
              <p:nvPr/>
            </p:nvSpPr>
            <p:spPr>
              <a:xfrm>
                <a:off x="10200755" y="822953"/>
                <a:ext cx="57610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624554" y="1247067"/>
                <a:ext cx="2377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ge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Increasing years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600895" y="1565878"/>
                <a:ext cx="239050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der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Male vs female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606404" y="1920364"/>
                <a:ext cx="29992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Count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Increasing number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604326" y="2288145"/>
                <a:ext cx="29731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DH status </a:t>
                </a:r>
                <a:r>
                  <a:rPr lang="en-US" altLang="zh-CN" sz="120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utation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s wild) 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590776" y="2671057"/>
                <a:ext cx="427761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MT promoter status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ethylated vs </a:t>
                </a:r>
                <a:r>
                  <a:rPr lang="en-US" altLang="zh-CN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methylated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627019" y="3052052"/>
                <a:ext cx="3108956" cy="3839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r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7 gain/</a:t>
                </a:r>
                <a:r>
                  <a:rPr lang="en-US" altLang="zh-CN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r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0 loss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Yes vs no) 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624554" y="4280542"/>
                <a:ext cx="310895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RX status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utation vs wild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624554" y="4653803"/>
                <a:ext cx="25845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P1 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 </a:t>
                </a:r>
                <a:r>
                  <a:rPr lang="en-US" altLang="zh-CN" sz="12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ncreasing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number)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4862225" y="908185"/>
                <a:ext cx="304839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            95% CI             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8634815" y="921042"/>
                <a:ext cx="307011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           95% CI             P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590776" y="5134859"/>
                <a:ext cx="1085657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old values indicate P&lt;0.05. HR, hazard ratio; OS, overall survival ; CI, confidence interval. 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4712687" y="1247067"/>
                <a:ext cx="35523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52       1.08−1.076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14E-05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4725751" y="1536217"/>
                <a:ext cx="339383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88       0.488−1.272        0.330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4732478" y="1934669"/>
                <a:ext cx="352749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95       0.983−1.007        0.407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4768797" y="2340516"/>
                <a:ext cx="35967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144       0.035−0.596 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8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4768797" y="2709848"/>
                <a:ext cx="36327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82       0.352−0.960  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34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4761164" y="3082271"/>
                <a:ext cx="37363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360       0.820−2.256        0.233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4763224" y="3814215"/>
                <a:ext cx="36330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936       1.416−6.090  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4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627019" y="3455087"/>
                <a:ext cx="322912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r</a:t>
                </a:r>
                <a:r>
                  <a:rPr lang="en-US" altLang="zh-CN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19/20 co-gain </a:t>
                </a:r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altLang="zh-CN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es vs no</a:t>
                </a:r>
                <a:r>
                  <a:rPr lang="zh-CN" alt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）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4761958" y="3457867"/>
                <a:ext cx="344054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83       0.218−1.068        0.072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4757999" y="4264817"/>
                <a:ext cx="38048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80       0.044−0.746  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8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8571494" y="1269568"/>
                <a:ext cx="33383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49      1.021−1.078 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1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8594179" y="1589238"/>
                <a:ext cx="330401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765      0.438−1.334     0.588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8607824" y="1945078"/>
                <a:ext cx="36022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982      0.968−0.996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11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8630940" y="2291720"/>
                <a:ext cx="359278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77      0.001−8.937     0.290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8630940" y="3039363"/>
                <a:ext cx="330063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09      0.562−1.813     0.975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8630940" y="2681575"/>
                <a:ext cx="35961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51      0.481−1.504     0.578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8669858" y="3451603"/>
                <a:ext cx="333650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66      0.102−0.695     </a:t>
                </a:r>
                <a:r>
                  <a:rPr lang="en-US" altLang="zh-CN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07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8692545" y="4229702"/>
                <a:ext cx="32806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481     0.056−755.420  0.441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>
                <a:off x="8669858" y="3833058"/>
                <a:ext cx="342967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344      0.548−3.300     0.519</a:t>
                </a:r>
                <a:endPara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文本框 52"/>
            <p:cNvSpPr txBox="1"/>
            <p:nvPr/>
          </p:nvSpPr>
          <p:spPr>
            <a:xfrm>
              <a:off x="414369" y="4626040"/>
              <a:ext cx="31089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 status 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utation vs wild)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4507586" y="5447366"/>
              <a:ext cx="38048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94       1.013−1.651        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9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8474671" y="5412229"/>
              <a:ext cx="32806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57      1.058−1.741     </a:t>
              </a:r>
              <a:r>
                <a:rPr lang="en-US" altLang="zh-CN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6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37694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229</Words>
  <Application>Microsoft Office PowerPoint</Application>
  <PresentationFormat>宽屏</PresentationFormat>
  <Paragraphs>3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ong gao</dc:creator>
  <cp:lastModifiedBy>P53</cp:lastModifiedBy>
  <cp:revision>37</cp:revision>
  <dcterms:created xsi:type="dcterms:W3CDTF">2020-03-15T00:53:25Z</dcterms:created>
  <dcterms:modified xsi:type="dcterms:W3CDTF">2021-06-05T10:03:32Z</dcterms:modified>
</cp:coreProperties>
</file>